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aisabel.torres" initials="a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803" autoAdjust="0"/>
  </p:normalViewPr>
  <p:slideViewPr>
    <p:cSldViewPr snapToObjects="1">
      <p:cViewPr>
        <p:scale>
          <a:sx n="150" d="100"/>
          <a:sy n="150" d="100"/>
        </p:scale>
        <p:origin x="182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4-01-20T13:10:44.425" idx="2">
    <p:pos x="1084" y="724"/>
    <p:text>No estoy segura de este título...</p:tex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 dirty="0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_tradn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06212-9E6A-7441-A218-558E46EC507B}" type="datetimeFigureOut">
              <a:rPr lang="es-ES_tradnl" smtClean="0"/>
              <a:pPr/>
              <a:t>18/01/2015</a:t>
            </a:fld>
            <a:endParaRPr lang="es-ES_tradnl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E4D76-8EB0-9A4A-BF24-32B595D66CED}" type="slidenum">
              <a:rPr lang="es-ES_tradnl" smtClean="0"/>
              <a:pPr/>
              <a:t>‹Nº›</a:t>
            </a:fld>
            <a:endParaRPr lang="es-ES_tradnl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50 Grupo"/>
          <p:cNvGrpSpPr/>
          <p:nvPr/>
        </p:nvGrpSpPr>
        <p:grpSpPr>
          <a:xfrm>
            <a:off x="5384403" y="332656"/>
            <a:ext cx="5395210" cy="2164320"/>
            <a:chOff x="304800" y="291121"/>
            <a:chExt cx="5395210" cy="2164320"/>
          </a:xfrm>
        </p:grpSpPr>
        <p:sp>
          <p:nvSpPr>
            <p:cNvPr id="52" name="Rectángulo 5"/>
            <p:cNvSpPr/>
            <p:nvPr/>
          </p:nvSpPr>
          <p:spPr>
            <a:xfrm>
              <a:off x="2280399" y="1540778"/>
              <a:ext cx="857250" cy="303212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53" name="Rectángulo 6"/>
            <p:cNvSpPr/>
            <p:nvPr/>
          </p:nvSpPr>
          <p:spPr>
            <a:xfrm>
              <a:off x="1371600" y="919837"/>
              <a:ext cx="685800" cy="30480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TLM</a:t>
              </a:r>
              <a:endParaRPr lang="es-ES_tradnl" sz="12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cxnSp>
          <p:nvCxnSpPr>
            <p:cNvPr id="54" name="Conector recto de flecha 8"/>
            <p:cNvCxnSpPr>
              <a:stCxn id="53" idx="3"/>
              <a:endCxn id="52" idx="0"/>
            </p:cNvCxnSpPr>
            <p:nvPr/>
          </p:nvCxnSpPr>
          <p:spPr>
            <a:xfrm>
              <a:off x="2057400" y="1072237"/>
              <a:ext cx="651624" cy="468541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ctor recto de flecha 12"/>
            <p:cNvCxnSpPr/>
            <p:nvPr/>
          </p:nvCxnSpPr>
          <p:spPr>
            <a:xfrm>
              <a:off x="1143000" y="1682632"/>
              <a:ext cx="1104900" cy="11389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ector recto de flecha 14"/>
            <p:cNvCxnSpPr/>
            <p:nvPr/>
          </p:nvCxnSpPr>
          <p:spPr>
            <a:xfrm rot="5400000" flipH="1" flipV="1">
              <a:off x="862450" y="1057740"/>
              <a:ext cx="449036" cy="497537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CuadroTexto 13"/>
            <p:cNvSpPr txBox="1"/>
            <p:nvPr/>
          </p:nvSpPr>
          <p:spPr>
            <a:xfrm>
              <a:off x="304800" y="1067077"/>
              <a:ext cx="9144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β= -0.243*</a:t>
              </a:r>
              <a:endParaRPr lang="es-ES_tradnl" sz="1000" i="1" dirty="0" smtClean="0">
                <a:solidFill>
                  <a:srgbClr val="000000"/>
                </a:solidFill>
                <a:latin typeface="Times New Roman"/>
                <a:cs typeface="Times New Roman"/>
              </a:endParaRPr>
            </a:p>
            <a:p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8" name="CuadroTexto 15"/>
            <p:cNvSpPr txBox="1"/>
            <p:nvPr/>
          </p:nvSpPr>
          <p:spPr>
            <a:xfrm>
              <a:off x="1295399" y="1690794"/>
              <a:ext cx="971551" cy="400110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β’= -0.012</a:t>
              </a:r>
              <a:endParaRPr lang="es-ES_tradnl" sz="1000" i="1" dirty="0" smtClean="0">
                <a:solidFill>
                  <a:srgbClr val="000000"/>
                </a:solidFill>
                <a:latin typeface="Times New Roman"/>
                <a:cs typeface="Times New Roman"/>
              </a:endParaRPr>
            </a:p>
            <a:p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9" name="CuadroTexto 16"/>
            <p:cNvSpPr txBox="1"/>
            <p:nvPr/>
          </p:nvSpPr>
          <p:spPr>
            <a:xfrm>
              <a:off x="2438401" y="1044463"/>
              <a:ext cx="933450" cy="400110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β= 0.913 **</a:t>
              </a:r>
              <a:endParaRPr lang="es-ES_tradnl" sz="1000" i="1" dirty="0" smtClean="0">
                <a:solidFill>
                  <a:srgbClr val="000000"/>
                </a:solidFill>
                <a:latin typeface="Times New Roman"/>
                <a:cs typeface="Times New Roman"/>
              </a:endParaRPr>
            </a:p>
            <a:p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0" name="Rectángulo 11"/>
            <p:cNvSpPr/>
            <p:nvPr/>
          </p:nvSpPr>
          <p:spPr>
            <a:xfrm>
              <a:off x="457200" y="367514"/>
              <a:ext cx="685800" cy="30480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2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RF</a:t>
              </a:r>
              <a:endParaRPr lang="es-ES_tradnl" sz="12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1" name="Rectángulo 18"/>
            <p:cNvSpPr/>
            <p:nvPr/>
          </p:nvSpPr>
          <p:spPr>
            <a:xfrm>
              <a:off x="2266950" y="367514"/>
              <a:ext cx="895350" cy="303212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sz="1600" dirty="0" smtClean="0">
                <a:solidFill>
                  <a:srgbClr val="000000"/>
                </a:solidFill>
                <a:latin typeface="Times New Roman"/>
                <a:cs typeface="Times New Roman"/>
              </a:endParaRPr>
            </a:p>
            <a:p>
              <a:pPr algn="ctr"/>
              <a:r>
                <a:rPr lang="es-ES_tradnl" sz="12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MC</a:t>
              </a:r>
            </a:p>
            <a:p>
              <a:pPr algn="ctr"/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cxnSp>
          <p:nvCxnSpPr>
            <p:cNvPr id="62" name="Conector recto de flecha 19"/>
            <p:cNvCxnSpPr>
              <a:stCxn id="60" idx="3"/>
            </p:cNvCxnSpPr>
            <p:nvPr/>
          </p:nvCxnSpPr>
          <p:spPr>
            <a:xfrm flipV="1">
              <a:off x="1143000" y="506566"/>
              <a:ext cx="1081369" cy="13348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CuadroTexto 20"/>
            <p:cNvSpPr txBox="1"/>
            <p:nvPr/>
          </p:nvSpPr>
          <p:spPr>
            <a:xfrm>
              <a:off x="1295402" y="506566"/>
              <a:ext cx="990598" cy="400110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β= -0.233**</a:t>
              </a:r>
              <a:endParaRPr lang="es-ES_tradnl" sz="1000" i="1" dirty="0" smtClean="0">
                <a:solidFill>
                  <a:srgbClr val="000000"/>
                </a:solidFill>
                <a:latin typeface="Times New Roman"/>
                <a:cs typeface="Times New Roman"/>
              </a:endParaRPr>
            </a:p>
            <a:p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4" name="CuadroTexto 17"/>
            <p:cNvSpPr txBox="1"/>
            <p:nvPr/>
          </p:nvSpPr>
          <p:spPr>
            <a:xfrm>
              <a:off x="432792" y="1916832"/>
              <a:ext cx="5267218" cy="538609"/>
            </a:xfrm>
            <a:prstGeom prst="rect">
              <a:avLst/>
            </a:prstGeom>
            <a:noFill/>
            <a:effectLst/>
          </p:spPr>
          <p:txBody>
            <a:bodyPr wrap="square" rtlCol="0" anchor="t">
              <a:spAutoFit/>
            </a:bodyPr>
            <a:lstStyle/>
            <a:p>
              <a:pPr algn="just"/>
              <a:endParaRPr lang="es-ES_tradnl" sz="1000" dirty="0" smtClean="0">
                <a:latin typeface="Times New Roman"/>
                <a:cs typeface="Times New Roman"/>
              </a:endParaRPr>
            </a:p>
            <a:p>
              <a:pPr algn="just"/>
              <a:r>
                <a:rPr lang="es-ES_tradnl" sz="1000" dirty="0" err="1" smtClean="0">
                  <a:latin typeface="Times New Roman"/>
                  <a:cs typeface="Times New Roman"/>
                </a:rPr>
                <a:t>Sobel</a:t>
              </a:r>
              <a:r>
                <a:rPr lang="es-ES_tradnl" sz="1000" dirty="0" smtClean="0">
                  <a:latin typeface="Times New Roman"/>
                  <a:cs typeface="Times New Roman"/>
                </a:rPr>
                <a:t> Test: -2.79**</a:t>
              </a:r>
              <a:endParaRPr lang="es-ES_tradnl" sz="1000" i="1" dirty="0" smtClean="0">
                <a:latin typeface="Times New Roman"/>
                <a:cs typeface="Times New Roman"/>
              </a:endParaRPr>
            </a:p>
            <a:p>
              <a:endParaRPr lang="es-ES_tradnl" sz="900" dirty="0">
                <a:latin typeface="Times New Roman"/>
                <a:cs typeface="Times New Roman"/>
              </a:endParaRPr>
            </a:p>
          </p:txBody>
        </p:sp>
        <p:sp>
          <p:nvSpPr>
            <p:cNvPr id="65" name="CuadroTexto 92"/>
            <p:cNvSpPr txBox="1"/>
            <p:nvPr/>
          </p:nvSpPr>
          <p:spPr>
            <a:xfrm>
              <a:off x="400050" y="875898"/>
              <a:ext cx="895351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Equation 1</a:t>
              </a:r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6" name="CuadroTexto 112"/>
            <p:cNvSpPr txBox="1"/>
            <p:nvPr/>
          </p:nvSpPr>
          <p:spPr>
            <a:xfrm>
              <a:off x="1295401" y="1447800"/>
              <a:ext cx="895349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Equation 3</a:t>
              </a:r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7" name="CuadroTexto 113"/>
            <p:cNvSpPr txBox="1"/>
            <p:nvPr/>
          </p:nvSpPr>
          <p:spPr>
            <a:xfrm>
              <a:off x="2324100" y="875898"/>
              <a:ext cx="81915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Equation 3</a:t>
              </a:r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8" name="CuadroTexto 114"/>
            <p:cNvSpPr txBox="1"/>
            <p:nvPr/>
          </p:nvSpPr>
          <p:spPr>
            <a:xfrm>
              <a:off x="1295401" y="291121"/>
              <a:ext cx="8572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0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Equation 2</a:t>
              </a:r>
              <a:endParaRPr lang="es-ES_tradnl" sz="10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9" name="Rectángulo 6"/>
            <p:cNvSpPr/>
            <p:nvPr/>
          </p:nvSpPr>
          <p:spPr>
            <a:xfrm>
              <a:off x="457200" y="1541621"/>
              <a:ext cx="685800" cy="30480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_tradnl" sz="11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RF</a:t>
              </a:r>
              <a:endParaRPr lang="es-ES_tradnl" sz="11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</p:grpSp>
      <p:sp>
        <p:nvSpPr>
          <p:cNvPr id="70" name="69 Rectángulo"/>
          <p:cNvSpPr/>
          <p:nvPr/>
        </p:nvSpPr>
        <p:spPr>
          <a:xfrm>
            <a:off x="2211147" y="116632"/>
            <a:ext cx="6399644" cy="2592288"/>
          </a:xfrm>
          <a:prstGeom prst="rect">
            <a:avLst/>
          </a:prstGeom>
          <a:noFill/>
          <a:ln w="31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77" name="76 Grupo"/>
          <p:cNvGrpSpPr/>
          <p:nvPr/>
        </p:nvGrpSpPr>
        <p:grpSpPr>
          <a:xfrm>
            <a:off x="2252785" y="433744"/>
            <a:ext cx="3067051" cy="1991148"/>
            <a:chOff x="2228501" y="2359356"/>
            <a:chExt cx="3067051" cy="1991148"/>
          </a:xfrm>
        </p:grpSpPr>
        <p:grpSp>
          <p:nvGrpSpPr>
            <p:cNvPr id="48" name="47 Grupo"/>
            <p:cNvGrpSpPr/>
            <p:nvPr/>
          </p:nvGrpSpPr>
          <p:grpSpPr>
            <a:xfrm>
              <a:off x="2228501" y="2359356"/>
              <a:ext cx="3067051" cy="1991148"/>
              <a:chOff x="2190750" y="2282963"/>
              <a:chExt cx="3067051" cy="1991148"/>
            </a:xfrm>
          </p:grpSpPr>
          <p:grpSp>
            <p:nvGrpSpPr>
              <p:cNvPr id="29" name="28 Grupo"/>
              <p:cNvGrpSpPr/>
              <p:nvPr/>
            </p:nvGrpSpPr>
            <p:grpSpPr>
              <a:xfrm>
                <a:off x="2190750" y="2282963"/>
                <a:ext cx="3067051" cy="1799783"/>
                <a:chOff x="304800" y="367514"/>
                <a:chExt cx="3067051" cy="1799783"/>
              </a:xfrm>
            </p:grpSpPr>
            <p:sp>
              <p:nvSpPr>
                <p:cNvPr id="30" name="Rectángulo 4"/>
                <p:cNvSpPr/>
                <p:nvPr/>
              </p:nvSpPr>
              <p:spPr>
                <a:xfrm>
                  <a:off x="533400" y="1607419"/>
                  <a:ext cx="609600" cy="30321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_tradnl" sz="12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VPA</a:t>
                  </a:r>
                  <a:endParaRPr lang="es-ES_tradnl" sz="12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1" name="Rectángulo 5"/>
                <p:cNvSpPr/>
                <p:nvPr/>
              </p:nvSpPr>
              <p:spPr>
                <a:xfrm>
                  <a:off x="2280399" y="1617171"/>
                  <a:ext cx="857250" cy="30321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_tradnl" sz="12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BMC</a:t>
                  </a:r>
                </a:p>
              </p:txBody>
            </p:sp>
            <p:sp>
              <p:nvSpPr>
                <p:cNvPr id="32" name="Rectángulo 6"/>
                <p:cNvSpPr/>
                <p:nvPr/>
              </p:nvSpPr>
              <p:spPr>
                <a:xfrm>
                  <a:off x="1371600" y="996230"/>
                  <a:ext cx="685800" cy="304800"/>
                </a:xfrm>
                <a:prstGeom prst="rect">
                  <a:avLst/>
                </a:prstGeom>
                <a:noFill/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_tradnl" sz="12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TLM</a:t>
                  </a:r>
                  <a:endParaRPr lang="es-ES_tradnl" sz="12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cxnSp>
              <p:nvCxnSpPr>
                <p:cNvPr id="33" name="Conector recto de flecha 8"/>
                <p:cNvCxnSpPr>
                  <a:stCxn id="32" idx="3"/>
                  <a:endCxn id="31" idx="0"/>
                </p:cNvCxnSpPr>
                <p:nvPr/>
              </p:nvCxnSpPr>
              <p:spPr>
                <a:xfrm>
                  <a:off x="2057400" y="1148630"/>
                  <a:ext cx="651624" cy="468541"/>
                </a:xfrm>
                <a:prstGeom prst="straightConnector1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Conector recto de flecha 14"/>
                <p:cNvCxnSpPr>
                  <a:stCxn id="30" idx="0"/>
                </p:cNvCxnSpPr>
                <p:nvPr/>
              </p:nvCxnSpPr>
              <p:spPr>
                <a:xfrm flipV="1">
                  <a:off x="838200" y="1158385"/>
                  <a:ext cx="497536" cy="449034"/>
                </a:xfrm>
                <a:prstGeom prst="straightConnector1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CuadroTexto 13"/>
                <p:cNvSpPr txBox="1"/>
                <p:nvPr/>
              </p:nvSpPr>
              <p:spPr>
                <a:xfrm>
                  <a:off x="304800" y="1143470"/>
                  <a:ext cx="914401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β= -0.246*</a:t>
                  </a:r>
                  <a:endParaRPr lang="es-ES_tradnl" sz="1000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  <a:p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6" name="CuadroTexto 15"/>
                <p:cNvSpPr txBox="1"/>
                <p:nvPr/>
              </p:nvSpPr>
              <p:spPr>
                <a:xfrm>
                  <a:off x="1314449" y="1767187"/>
                  <a:ext cx="971551" cy="400110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β’= -0.014</a:t>
                  </a:r>
                  <a:endParaRPr lang="es-ES_tradnl" sz="1000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  <a:p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7" name="CuadroTexto 16"/>
                <p:cNvSpPr txBox="1"/>
                <p:nvPr/>
              </p:nvSpPr>
              <p:spPr>
                <a:xfrm>
                  <a:off x="2438401" y="1120856"/>
                  <a:ext cx="933450" cy="400110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β= 0.894**</a:t>
                  </a:r>
                  <a:endParaRPr lang="es-ES_tradnl" sz="1000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  <a:p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8" name="Rectángulo 11"/>
                <p:cNvSpPr/>
                <p:nvPr/>
              </p:nvSpPr>
              <p:spPr>
                <a:xfrm>
                  <a:off x="533400" y="443907"/>
                  <a:ext cx="609600" cy="304800"/>
                </a:xfrm>
                <a:prstGeom prst="rect">
                  <a:avLst/>
                </a:prstGeom>
                <a:noFill/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_tradnl" sz="12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VPA</a:t>
                  </a:r>
                  <a:endParaRPr lang="es-ES_tradnl" sz="12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9" name="Rectángulo 18"/>
                <p:cNvSpPr/>
                <p:nvPr/>
              </p:nvSpPr>
              <p:spPr>
                <a:xfrm>
                  <a:off x="2266950" y="367514"/>
                  <a:ext cx="895350" cy="303212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s-ES_tradnl" sz="12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BMC</a:t>
                  </a:r>
                  <a:endParaRPr lang="es-ES_tradnl" sz="12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cxnSp>
              <p:nvCxnSpPr>
                <p:cNvPr id="40" name="Conector recto de flecha 19"/>
                <p:cNvCxnSpPr>
                  <a:stCxn id="38" idx="3"/>
                </p:cNvCxnSpPr>
                <p:nvPr/>
              </p:nvCxnSpPr>
              <p:spPr>
                <a:xfrm flipV="1">
                  <a:off x="1143000" y="582959"/>
                  <a:ext cx="1081369" cy="13348"/>
                </a:xfrm>
                <a:prstGeom prst="straightConnector1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CuadroTexto 20"/>
                <p:cNvSpPr txBox="1"/>
                <p:nvPr/>
              </p:nvSpPr>
              <p:spPr>
                <a:xfrm>
                  <a:off x="1295402" y="582959"/>
                  <a:ext cx="990598" cy="400110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β= -0.233*</a:t>
                  </a:r>
                  <a:endParaRPr lang="es-ES_tradnl" sz="1000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  <a:p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2" name="CuadroTexto 92"/>
                <p:cNvSpPr txBox="1"/>
                <p:nvPr/>
              </p:nvSpPr>
              <p:spPr>
                <a:xfrm>
                  <a:off x="400050" y="952291"/>
                  <a:ext cx="895351" cy="246221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Equation 1</a:t>
                  </a:r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3" name="CuadroTexto 112"/>
                <p:cNvSpPr txBox="1"/>
                <p:nvPr/>
              </p:nvSpPr>
              <p:spPr>
                <a:xfrm>
                  <a:off x="1295401" y="1524193"/>
                  <a:ext cx="895349" cy="246221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Equation 3</a:t>
                  </a:r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4" name="CuadroTexto 113"/>
                <p:cNvSpPr txBox="1"/>
                <p:nvPr/>
              </p:nvSpPr>
              <p:spPr>
                <a:xfrm>
                  <a:off x="2324100" y="952291"/>
                  <a:ext cx="819150" cy="246221"/>
                </a:xfrm>
                <a:prstGeom prst="rect">
                  <a:avLst/>
                </a:prstGeom>
                <a:noFill/>
                <a:effectLst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Equation 3</a:t>
                  </a:r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45" name="CuadroTexto 114"/>
                <p:cNvSpPr txBox="1"/>
                <p:nvPr/>
              </p:nvSpPr>
              <p:spPr>
                <a:xfrm>
                  <a:off x="1295401" y="367514"/>
                  <a:ext cx="8572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1000" dirty="0" smtClean="0">
                      <a:solidFill>
                        <a:srgbClr val="000000"/>
                      </a:solidFill>
                      <a:latin typeface="Times New Roman"/>
                      <a:cs typeface="Times New Roman"/>
                    </a:rPr>
                    <a:t>Equation 2</a:t>
                  </a:r>
                  <a:endParaRPr lang="es-ES_tradnl" sz="1000" dirty="0">
                    <a:solidFill>
                      <a:srgbClr val="000000"/>
                    </a:solidFill>
                    <a:latin typeface="Times New Roman"/>
                    <a:cs typeface="Times New Roman"/>
                  </a:endParaRPr>
                </a:p>
              </p:txBody>
            </p:sp>
          </p:grpSp>
          <p:sp>
            <p:nvSpPr>
              <p:cNvPr id="47" name="46 Rectángulo"/>
              <p:cNvSpPr/>
              <p:nvPr/>
            </p:nvSpPr>
            <p:spPr>
              <a:xfrm>
                <a:off x="2540733" y="4027890"/>
                <a:ext cx="112883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s-ES_tradnl" sz="1000" dirty="0" err="1" smtClean="0">
                    <a:latin typeface="Times New Roman"/>
                    <a:cs typeface="Times New Roman"/>
                  </a:rPr>
                  <a:t>Sobel</a:t>
                </a:r>
                <a:r>
                  <a:rPr lang="es-ES_tradnl" sz="1000" dirty="0" smtClean="0">
                    <a:latin typeface="Times New Roman"/>
                    <a:cs typeface="Times New Roman"/>
                  </a:rPr>
                  <a:t> Test: -2.61*</a:t>
                </a:r>
                <a:endParaRPr lang="es-ES_tradnl" sz="1000" i="1" dirty="0" smtClean="0">
                  <a:latin typeface="Times New Roman"/>
                  <a:cs typeface="Times New Roman"/>
                </a:endParaRPr>
              </a:p>
            </p:txBody>
          </p:sp>
        </p:grpSp>
        <p:cxnSp>
          <p:nvCxnSpPr>
            <p:cNvPr id="72" name="Conector recto de flecha 14"/>
            <p:cNvCxnSpPr/>
            <p:nvPr/>
          </p:nvCxnSpPr>
          <p:spPr>
            <a:xfrm rot="5400000" flipH="1" flipV="1">
              <a:off x="2786151" y="3125975"/>
              <a:ext cx="449036" cy="497537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ector recto de flecha 14"/>
            <p:cNvCxnSpPr>
              <a:stCxn id="30" idx="3"/>
              <a:endCxn id="31" idx="1"/>
            </p:cNvCxnSpPr>
            <p:nvPr/>
          </p:nvCxnSpPr>
          <p:spPr>
            <a:xfrm>
              <a:off x="3066701" y="3750867"/>
              <a:ext cx="1137399" cy="9752"/>
            </a:xfrm>
            <a:prstGeom prst="straightConnector1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1 CuadroTexto"/>
          <p:cNvSpPr txBox="1"/>
          <p:nvPr/>
        </p:nvSpPr>
        <p:spPr>
          <a:xfrm>
            <a:off x="2376511" y="187522"/>
            <a:ext cx="375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1.a</a:t>
            </a:r>
            <a:endParaRPr lang="es-ES" sz="1200" dirty="0"/>
          </a:p>
        </p:txBody>
      </p:sp>
      <p:sp>
        <p:nvSpPr>
          <p:cNvPr id="46" name="45 CuadroTexto"/>
          <p:cNvSpPr txBox="1"/>
          <p:nvPr/>
        </p:nvSpPr>
        <p:spPr>
          <a:xfrm>
            <a:off x="5551904" y="132050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1.b</a:t>
            </a:r>
            <a:endParaRPr lang="es-E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4</TotalTime>
  <Words>76</Words>
  <Application>Microsoft Office PowerPoint</Application>
  <PresentationFormat>Presentación en pantalla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  -  IMC</dc:title>
  <dc:creator>Ana Diez Fernandez</dc:creator>
  <cp:lastModifiedBy>anaisabel.torres</cp:lastModifiedBy>
  <cp:revision>105</cp:revision>
  <dcterms:created xsi:type="dcterms:W3CDTF">2013-07-30T11:24:06Z</dcterms:created>
  <dcterms:modified xsi:type="dcterms:W3CDTF">2015-01-18T16:24:18Z</dcterms:modified>
</cp:coreProperties>
</file>